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tif" ContentType="image/tiff"/>
  <Default Extension="rels" ContentType="application/vnd.openxmlformats-package.relationships+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6" d="100"/>
          <a:sy n="96" d="100"/>
        </p:scale>
        <p:origin x="-1464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F0CF4-386A-4650-8AC8-0B263863B509}" type="datetimeFigureOut">
              <a:rPr lang="en-US" smtClean="0"/>
              <a:t>7/2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8A4C4-CFFA-4D59-9F73-809FEE0812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411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F0CF4-386A-4650-8AC8-0B263863B509}" type="datetimeFigureOut">
              <a:rPr lang="en-US" smtClean="0"/>
              <a:t>7/2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8A4C4-CFFA-4D59-9F73-809FEE0812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3506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F0CF4-386A-4650-8AC8-0B263863B509}" type="datetimeFigureOut">
              <a:rPr lang="en-US" smtClean="0"/>
              <a:t>7/2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8A4C4-CFFA-4D59-9F73-809FEE0812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09638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F0CF4-386A-4650-8AC8-0B263863B509}" type="datetimeFigureOut">
              <a:rPr lang="en-US" smtClean="0"/>
              <a:t>7/2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8A4C4-CFFA-4D59-9F73-809FEE0812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23397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F0CF4-386A-4650-8AC8-0B263863B509}" type="datetimeFigureOut">
              <a:rPr lang="en-US" smtClean="0"/>
              <a:t>7/2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8A4C4-CFFA-4D59-9F73-809FEE0812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517187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F0CF4-386A-4650-8AC8-0B263863B509}" type="datetimeFigureOut">
              <a:rPr lang="en-US" smtClean="0"/>
              <a:t>7/23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8A4C4-CFFA-4D59-9F73-809FEE0812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7365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F0CF4-386A-4650-8AC8-0B263863B509}" type="datetimeFigureOut">
              <a:rPr lang="en-US" smtClean="0"/>
              <a:t>7/23/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8A4C4-CFFA-4D59-9F73-809FEE0812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97331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F0CF4-386A-4650-8AC8-0B263863B509}" type="datetimeFigureOut">
              <a:rPr lang="en-US" smtClean="0"/>
              <a:t>7/23/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8A4C4-CFFA-4D59-9F73-809FEE0812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38250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F0CF4-386A-4650-8AC8-0B263863B509}" type="datetimeFigureOut">
              <a:rPr lang="en-US" smtClean="0"/>
              <a:t>7/23/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8A4C4-CFFA-4D59-9F73-809FEE0812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65985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F0CF4-386A-4650-8AC8-0B263863B509}" type="datetimeFigureOut">
              <a:rPr lang="en-US" smtClean="0"/>
              <a:t>7/23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8A4C4-CFFA-4D59-9F73-809FEE0812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08743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6F0CF4-386A-4650-8AC8-0B263863B509}" type="datetimeFigureOut">
              <a:rPr lang="en-US" smtClean="0"/>
              <a:t>7/23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8A4C4-CFFA-4D59-9F73-809FEE0812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9000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6F0CF4-386A-4650-8AC8-0B263863B509}" type="datetimeFigureOut">
              <a:rPr lang="en-US" smtClean="0"/>
              <a:t>7/2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88A4C4-CFFA-4D59-9F73-809FEE0812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5989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4" Type="http://schemas.openxmlformats.org/officeDocument/2006/relationships/image" Target="../media/image3.tiff"/><Relationship Id="rId5" Type="http://schemas.openxmlformats.org/officeDocument/2006/relationships/image" Target="../media/image4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4" Type="http://schemas.openxmlformats.org/officeDocument/2006/relationships/image" Target="../media/image7.jpeg"/><Relationship Id="rId5" Type="http://schemas.openxmlformats.org/officeDocument/2006/relationships/image" Target="../media/image8.ti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5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1676400" y="-5654"/>
            <a:ext cx="1619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Verdana" pitchFamily="34" charset="0"/>
                <a:ea typeface="Verdana" pitchFamily="34" charset="0"/>
                <a:cs typeface="Verdana" pitchFamily="34" charset="0"/>
              </a:rPr>
              <a:t>MCT1</a:t>
            </a:r>
            <a:endParaRPr lang="en-US" dirty="0">
              <a:latin typeface="Verdana" pitchFamily="34" charset="0"/>
              <a:ea typeface="Verdana" pitchFamily="34" charset="0"/>
              <a:cs typeface="Verdana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533400" y="76200"/>
            <a:ext cx="6452107" cy="6767156"/>
            <a:chOff x="-558293" y="-104766"/>
            <a:chExt cx="6452107" cy="6767156"/>
          </a:xfrm>
        </p:grpSpPr>
        <p:pic>
          <p:nvPicPr>
            <p:cNvPr id="52" name="Picture 51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" r="14749"/>
            <a:stretch/>
          </p:blipFill>
          <p:spPr>
            <a:xfrm>
              <a:off x="3480307" y="4449239"/>
              <a:ext cx="2413506" cy="215670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1" name="Picture 50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30" r="15697"/>
            <a:stretch/>
          </p:blipFill>
          <p:spPr>
            <a:xfrm>
              <a:off x="3480307" y="2181234"/>
              <a:ext cx="2413506" cy="220283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0" name="Picture 49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480307" y="-104766"/>
              <a:ext cx="2413507" cy="221127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3" name="Picture 42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335"/>
            <a:stretch/>
          </p:blipFill>
          <p:spPr>
            <a:xfrm>
              <a:off x="762000" y="1082981"/>
              <a:ext cx="2540243" cy="441369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" name="TextBox 1"/>
            <p:cNvSpPr txBox="1"/>
            <p:nvPr/>
          </p:nvSpPr>
          <p:spPr>
            <a:xfrm>
              <a:off x="3379214" y="6354613"/>
              <a:ext cx="63449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10x</a:t>
              </a:r>
              <a:endParaRPr lang="en-US" sz="14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381000" y="838200"/>
              <a:ext cx="381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a</a:t>
              </a:r>
              <a:endParaRPr lang="en-US" sz="1400" b="1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sp>
          <p:nvSpPr>
            <p:cNvPr id="27" name="Rectangle 26"/>
            <p:cNvSpPr/>
            <p:nvPr/>
          </p:nvSpPr>
          <p:spPr>
            <a:xfrm>
              <a:off x="2286000" y="1712118"/>
              <a:ext cx="152400" cy="19288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7" name="Straight Connector 6"/>
            <p:cNvCxnSpPr>
              <a:stCxn id="27" idx="3"/>
              <a:endCxn id="50" idx="1"/>
            </p:cNvCxnSpPr>
            <p:nvPr/>
          </p:nvCxnSpPr>
          <p:spPr>
            <a:xfrm flipV="1">
              <a:off x="2438400" y="1000870"/>
              <a:ext cx="1041907" cy="807689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>
              <a:stCxn id="70" idx="3"/>
              <a:endCxn id="51" idx="1"/>
            </p:cNvCxnSpPr>
            <p:nvPr/>
          </p:nvCxnSpPr>
          <p:spPr>
            <a:xfrm>
              <a:off x="1192619" y="3104465"/>
              <a:ext cx="2287688" cy="178185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>
              <a:stCxn id="71" idx="3"/>
              <a:endCxn id="52" idx="1"/>
            </p:cNvCxnSpPr>
            <p:nvPr/>
          </p:nvCxnSpPr>
          <p:spPr>
            <a:xfrm>
              <a:off x="2184521" y="4992443"/>
              <a:ext cx="1295786" cy="53515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Box 64"/>
            <p:cNvSpPr txBox="1"/>
            <p:nvPr/>
          </p:nvSpPr>
          <p:spPr>
            <a:xfrm>
              <a:off x="-468884" y="1055489"/>
              <a:ext cx="73558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Nevi</a:t>
              </a:r>
              <a:endParaRPr lang="en-US" sz="16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-558293" y="3257490"/>
              <a:ext cx="1371601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Metastatic</a:t>
              </a:r>
            </a:p>
            <a:p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Melanoma</a:t>
              </a:r>
              <a:endParaRPr lang="en-US" sz="16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-558293" y="2133600"/>
              <a:ext cx="1320293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Primary</a:t>
              </a:r>
            </a:p>
            <a:p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Melanoma</a:t>
              </a:r>
              <a:endParaRPr lang="en-US" sz="16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sp>
          <p:nvSpPr>
            <p:cNvPr id="70" name="Rectangle 69"/>
            <p:cNvSpPr/>
            <p:nvPr/>
          </p:nvSpPr>
          <p:spPr>
            <a:xfrm>
              <a:off x="1040219" y="3008024"/>
              <a:ext cx="152400" cy="19288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1" name="Rectangle 70"/>
            <p:cNvSpPr/>
            <p:nvPr/>
          </p:nvSpPr>
          <p:spPr>
            <a:xfrm>
              <a:off x="2032121" y="4896002"/>
              <a:ext cx="152400" cy="19288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3099307" y="-104766"/>
              <a:ext cx="381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Verdana" pitchFamily="34" charset="0"/>
                  <a:ea typeface="Verdana" pitchFamily="34" charset="0"/>
                  <a:cs typeface="Verdana" pitchFamily="34" charset="0"/>
                </a:rPr>
                <a:t>b</a:t>
              </a:r>
            </a:p>
          </p:txBody>
        </p:sp>
      </p:grpSp>
      <p:sp>
        <p:nvSpPr>
          <p:cNvPr id="21" name="TextBox 20"/>
          <p:cNvSpPr txBox="1"/>
          <p:nvPr/>
        </p:nvSpPr>
        <p:spPr>
          <a:xfrm>
            <a:off x="0" y="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5830181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/>
          <p:cNvSpPr txBox="1"/>
          <p:nvPr/>
        </p:nvSpPr>
        <p:spPr>
          <a:xfrm>
            <a:off x="2266950" y="164068"/>
            <a:ext cx="1619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latin typeface="Verdana" pitchFamily="34" charset="0"/>
                <a:ea typeface="Verdana" pitchFamily="34" charset="0"/>
                <a:cs typeface="Verdana" pitchFamily="34" charset="0"/>
              </a:rPr>
              <a:t>MCT4</a:t>
            </a:r>
            <a:endParaRPr lang="en-US" dirty="0">
              <a:latin typeface="Verdana" pitchFamily="34" charset="0"/>
              <a:ea typeface="Verdana" pitchFamily="34" charset="0"/>
              <a:cs typeface="Verdana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533400" y="53011"/>
            <a:ext cx="6673418" cy="6790345"/>
            <a:chOff x="-586775" y="70632"/>
            <a:chExt cx="6673418" cy="6790345"/>
          </a:xfrm>
        </p:grpSpPr>
        <p:pic>
          <p:nvPicPr>
            <p:cNvPr id="47" name="Picture 46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34775" y="4580503"/>
              <a:ext cx="2451868" cy="221891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5" name="Picture 4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46433" y="2286000"/>
              <a:ext cx="2424174" cy="22098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4" name="Picture 43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34775" y="70632"/>
              <a:ext cx="2435832" cy="215679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42" name="Picture 41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130"/>
            <a:stretch/>
          </p:blipFill>
          <p:spPr>
            <a:xfrm>
              <a:off x="809624" y="1149878"/>
              <a:ext cx="2497383" cy="426032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2" name="TextBox 1"/>
            <p:cNvSpPr txBox="1"/>
            <p:nvPr/>
          </p:nvSpPr>
          <p:spPr>
            <a:xfrm>
              <a:off x="3505200" y="6553200"/>
              <a:ext cx="56629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10x</a:t>
              </a:r>
              <a:endParaRPr lang="en-US" sz="14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11106" y="896780"/>
              <a:ext cx="381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Verdana" pitchFamily="34" charset="0"/>
                  <a:ea typeface="Verdana" pitchFamily="34" charset="0"/>
                  <a:cs typeface="Verdana" pitchFamily="34" charset="0"/>
                </a:rPr>
                <a:t>a</a:t>
              </a:r>
            </a:p>
          </p:txBody>
        </p:sp>
        <p:sp>
          <p:nvSpPr>
            <p:cNvPr id="27" name="Rectangle 26"/>
            <p:cNvSpPr/>
            <p:nvPr/>
          </p:nvSpPr>
          <p:spPr>
            <a:xfrm>
              <a:off x="2876108" y="1319609"/>
              <a:ext cx="152400" cy="18653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7" name="Straight Connector 6"/>
            <p:cNvCxnSpPr>
              <a:stCxn id="27" idx="3"/>
              <a:endCxn id="44" idx="1"/>
            </p:cNvCxnSpPr>
            <p:nvPr/>
          </p:nvCxnSpPr>
          <p:spPr>
            <a:xfrm flipV="1">
              <a:off x="3028508" y="1149027"/>
              <a:ext cx="606267" cy="263848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>
              <a:stCxn id="167" idx="3"/>
              <a:endCxn id="45" idx="1"/>
            </p:cNvCxnSpPr>
            <p:nvPr/>
          </p:nvCxnSpPr>
          <p:spPr>
            <a:xfrm>
              <a:off x="2570981" y="2477783"/>
              <a:ext cx="1075452" cy="913117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/>
            <p:cNvCxnSpPr>
              <a:endCxn id="47" idx="1"/>
            </p:cNvCxnSpPr>
            <p:nvPr/>
          </p:nvCxnSpPr>
          <p:spPr>
            <a:xfrm>
              <a:off x="2787176" y="4519250"/>
              <a:ext cx="847599" cy="1170712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4" name="TextBox 163"/>
            <p:cNvSpPr txBox="1"/>
            <p:nvPr/>
          </p:nvSpPr>
          <p:spPr>
            <a:xfrm>
              <a:off x="-586775" y="1139184"/>
              <a:ext cx="73558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Nevi</a:t>
              </a:r>
              <a:endParaRPr lang="en-US" sz="16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-586775" y="2209800"/>
              <a:ext cx="1348775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Primary</a:t>
              </a:r>
            </a:p>
            <a:p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Melanoma</a:t>
              </a:r>
              <a:endParaRPr lang="en-US" sz="16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sp>
          <p:nvSpPr>
            <p:cNvPr id="166" name="TextBox 165"/>
            <p:cNvSpPr txBox="1"/>
            <p:nvPr/>
          </p:nvSpPr>
          <p:spPr>
            <a:xfrm>
              <a:off x="-586775" y="3276600"/>
              <a:ext cx="1455081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Metastatic</a:t>
              </a:r>
            </a:p>
            <a:p>
              <a:r>
                <a:rPr lang="en-US" sz="16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Melanoma</a:t>
              </a:r>
              <a:endParaRPr lang="en-US" sz="16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sp>
          <p:nvSpPr>
            <p:cNvPr id="167" name="Rectangle 166"/>
            <p:cNvSpPr/>
            <p:nvPr/>
          </p:nvSpPr>
          <p:spPr>
            <a:xfrm>
              <a:off x="2418581" y="2384517"/>
              <a:ext cx="152400" cy="18653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69" name="Rectangle 168"/>
            <p:cNvSpPr/>
            <p:nvPr/>
          </p:nvSpPr>
          <p:spPr>
            <a:xfrm>
              <a:off x="2634776" y="4376350"/>
              <a:ext cx="152400" cy="18653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124200" y="70632"/>
              <a:ext cx="381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b="1" dirty="0">
                  <a:latin typeface="Verdana" pitchFamily="34" charset="0"/>
                  <a:ea typeface="Verdana" pitchFamily="34" charset="0"/>
                  <a:cs typeface="Verdana" pitchFamily="34" charset="0"/>
                </a:rPr>
                <a:t>b</a:t>
              </a:r>
            </a:p>
          </p:txBody>
        </p:sp>
      </p:grpSp>
      <p:sp>
        <p:nvSpPr>
          <p:cNvPr id="21" name="TextBox 20"/>
          <p:cNvSpPr txBox="1"/>
          <p:nvPr/>
        </p:nvSpPr>
        <p:spPr>
          <a:xfrm>
            <a:off x="0" y="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1466678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20</Words>
  <Application>Microsoft Macintosh PowerPoint</Application>
  <PresentationFormat>On-screen Show (4:3)</PresentationFormat>
  <Paragraphs>20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UP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rgios</dc:creator>
  <cp:lastModifiedBy>Stergios Moschos</cp:lastModifiedBy>
  <cp:revision>7</cp:revision>
  <dcterms:created xsi:type="dcterms:W3CDTF">2012-01-13T21:39:11Z</dcterms:created>
  <dcterms:modified xsi:type="dcterms:W3CDTF">2012-07-23T19:49:51Z</dcterms:modified>
</cp:coreProperties>
</file>